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5" r:id="rId3"/>
    <p:sldId id="266" r:id="rId4"/>
    <p:sldId id="268" r:id="rId5"/>
    <p:sldId id="269" r:id="rId6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269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967" autoAdjust="0"/>
    <p:restoredTop sz="94660"/>
  </p:normalViewPr>
  <p:slideViewPr>
    <p:cSldViewPr snapToGrid="0" showGuides="1">
      <p:cViewPr varScale="1">
        <p:scale>
          <a:sx n="62" d="100"/>
          <a:sy n="62" d="100"/>
        </p:scale>
        <p:origin x="102" y="1470"/>
      </p:cViewPr>
      <p:guideLst>
        <p:guide orient="horz" pos="4269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93037FC-E6E2-4967-A644-FB49D94B90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B5BECCE9-1D97-4B6D-A091-32D9A9EA85C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67051E3D-0038-4E4F-A2A9-C8FEE0E9FD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AA29-F329-4242-9D21-AC59C97C8A77}" type="datetimeFigureOut">
              <a:rPr lang="ko-KR" altLang="en-US" smtClean="0"/>
              <a:t>2021-11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687E0A8-68DE-4F7A-8748-C88E02107B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650F842-B173-4307-8EFB-2E910C09AD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939482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8467F9C1-BC4F-4C4C-AE39-3346D221B2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0E1BE548-D0E8-492E-AD75-45AA9B9F77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F9F1470-DDE7-4CCF-8F3E-F48FC2928C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AA29-F329-4242-9D21-AC59C97C8A77}" type="datetimeFigureOut">
              <a:rPr lang="ko-KR" altLang="en-US" smtClean="0"/>
              <a:t>2021-11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A6C7FE5-BD67-46DE-B6E7-B22F93B618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6C69396-F19F-4A7E-A046-412D05D7B1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395092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A6F43F54-35DC-424C-B609-25B4652B11D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232DA1F-5FB2-4912-BB3E-A016B3B881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C1A210C-567F-4157-B4A8-36AA7C82D4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AA29-F329-4242-9D21-AC59C97C8A77}" type="datetimeFigureOut">
              <a:rPr lang="ko-KR" altLang="en-US" smtClean="0"/>
              <a:t>2021-11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C7A3EE8-DBB4-4A0D-AE29-E1F2CA6A4C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D07FFAB-C8DA-48F7-8A06-BAAA192006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6656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512D0ED-F706-4FB9-8C99-470611B88C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E6566B27-93FF-4C75-B48B-22E1AFB144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C0D9255-584B-4F11-B779-6C34B33AD5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AA29-F329-4242-9D21-AC59C97C8A77}" type="datetimeFigureOut">
              <a:rPr lang="ko-KR" altLang="en-US" smtClean="0"/>
              <a:t>2021-11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B00AFD3-A800-45F6-A3A2-D3C3E71BDA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FD48A21-C403-485B-BDDA-91895CEC54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09077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6B3C7F6-6A39-490F-AC11-71323A5CC4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C441C08-D4DC-4177-86E2-29513489103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0623F69-9635-4B6F-9940-0685A3B492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AA29-F329-4242-9D21-AC59C97C8A77}" type="datetimeFigureOut">
              <a:rPr lang="ko-KR" altLang="en-US" smtClean="0"/>
              <a:t>2021-11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CE7A08E9-4D0C-46C1-A4B4-8E110E088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A82FB120-F34C-4B2E-B8FF-69E0A96103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608455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102479F-4258-4E87-8C25-E5D7A27F91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6C3252A9-43D0-4BF0-BB82-815A06C45FE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820877EC-227E-4965-A343-4B975FFD81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4DA6D62F-A9AD-420E-ADD5-8D68685A40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AA29-F329-4242-9D21-AC59C97C8A77}" type="datetimeFigureOut">
              <a:rPr lang="ko-KR" altLang="en-US" smtClean="0"/>
              <a:t>2021-11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4D890E6-99CF-4FE7-A105-AB5880E41A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E4AD7504-8DB6-44B4-B3CB-BC05DE009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248086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D618367-31BD-47C5-A4E2-E4824DFF44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AD3BAE39-D892-40DF-9E3C-4626700855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9590B65-4C0A-4BD2-8113-5CFA70B8C4C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5C6AAEF8-4111-48CB-97E2-BAB4FE58C21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96D548F8-3BD1-4516-B15A-DC7B9DD707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9B954F85-1ED4-456D-B53D-8D248C3406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AA29-F329-4242-9D21-AC59C97C8A77}" type="datetimeFigureOut">
              <a:rPr lang="ko-KR" altLang="en-US" smtClean="0"/>
              <a:t>2021-11-19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A67C4AEE-542F-41E1-90F2-F15D92505E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855EF53C-0B0F-44B8-B752-61422F1F59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099400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348E60D-ADC7-4D55-BA9C-5E2ECC2173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B4293620-3720-47DC-8C8B-2D266695C6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AA29-F329-4242-9D21-AC59C97C8A77}" type="datetimeFigureOut">
              <a:rPr lang="ko-KR" altLang="en-US" smtClean="0"/>
              <a:t>2021-11-19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7309B3D7-FCC9-45A2-A2AE-714776CB69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9BF7A64B-84F0-49CD-AC52-AE1AFFE3A4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88996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FAB2F92A-2B31-4DB2-8705-602D661FEB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AA29-F329-4242-9D21-AC59C97C8A77}" type="datetimeFigureOut">
              <a:rPr lang="ko-KR" altLang="en-US" smtClean="0"/>
              <a:t>2021-11-19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522EAE2A-6FE2-4582-9869-E0D9947C2C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7FA21B49-1C0F-4498-B4D2-E0E8181EAD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64259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3762432-6FEE-419A-A467-BDEA08FB3C8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91F9A7C-85E6-438F-956F-A8593AECC7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FA3E695-128D-4773-A21C-61207334E54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A3175626-6F95-4C05-9A58-1AE55581C3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AA29-F329-4242-9D21-AC59C97C8A77}" type="datetimeFigureOut">
              <a:rPr lang="ko-KR" altLang="en-US" smtClean="0"/>
              <a:t>2021-11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6C9DB457-F044-4E5B-9EF1-5586394857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8BF3393-6140-432D-B8D8-FDE75D252E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085191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B9F8353-8BD6-4269-B3D9-00304DF321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0175CC62-5D10-41B3-A537-02135D3E4B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00F50CA4-CD69-455E-8028-7AE10786CF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A176812-E52F-40A8-A56B-8B4D56DF83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92AA29-F329-4242-9D21-AC59C97C8A77}" type="datetimeFigureOut">
              <a:rPr lang="ko-KR" altLang="en-US" smtClean="0"/>
              <a:t>2021-11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23DC394F-EF53-481C-8AFD-0FCAC2FB69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B831F710-CE48-443B-9291-283779C456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550652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C48B4ACE-C07C-4D19-A121-1B2C433320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4E612B9-926F-4795-BC7D-7A4801E0C7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C07B579-747C-47C9-A281-B87C126BD9A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92AA29-F329-4242-9D21-AC59C97C8A77}" type="datetimeFigureOut">
              <a:rPr lang="ko-KR" altLang="en-US" smtClean="0"/>
              <a:t>2021-11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CDE7BD3-86AD-47BF-A99E-E648530AFC0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CBC3E9D-BFEA-4D41-9A3C-97415CAF9E9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D28039-DB00-4317-8EA6-4587E6551F4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454846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9.jpg"/><Relationship Id="rId4" Type="http://schemas.openxmlformats.org/officeDocument/2006/relationships/image" Target="../media/image8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g"/><Relationship Id="rId3" Type="http://schemas.openxmlformats.org/officeDocument/2006/relationships/image" Target="../media/image11.jp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jpg"/><Relationship Id="rId5" Type="http://schemas.openxmlformats.org/officeDocument/2006/relationships/image" Target="../media/image13.jpg"/><Relationship Id="rId4" Type="http://schemas.openxmlformats.org/officeDocument/2006/relationships/image" Target="../media/image1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png"/><Relationship Id="rId4" Type="http://schemas.openxmlformats.org/officeDocument/2006/relationships/image" Target="../media/image19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jpg"/><Relationship Id="rId5" Type="http://schemas.openxmlformats.org/officeDocument/2006/relationships/image" Target="../media/image24.jpg"/><Relationship Id="rId4" Type="http://schemas.openxmlformats.org/officeDocument/2006/relationships/image" Target="../media/image2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5166413-B860-4290-92FE-284B309C3354}"/>
              </a:ext>
            </a:extLst>
          </p:cNvPr>
          <p:cNvSpPr txBox="1"/>
          <p:nvPr/>
        </p:nvSpPr>
        <p:spPr>
          <a:xfrm>
            <a:off x="220504" y="-125292"/>
            <a:ext cx="1799278" cy="5799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lnSpc>
                <a:spcPct val="150000"/>
              </a:lnSpc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3 (A) 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9928884" y="979041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RAF6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4361BA54-F14F-42CC-A066-913816B5BB70}"/>
              </a:ext>
            </a:extLst>
          </p:cNvPr>
          <p:cNvSpPr/>
          <p:nvPr/>
        </p:nvSpPr>
        <p:spPr>
          <a:xfrm>
            <a:off x="5656102" y="411132"/>
            <a:ext cx="630729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2EE29B5-E471-4B21-9AF7-BEC6DE6F607B}"/>
              </a:ext>
            </a:extLst>
          </p:cNvPr>
          <p:cNvSpPr txBox="1"/>
          <p:nvPr/>
        </p:nvSpPr>
        <p:spPr>
          <a:xfrm>
            <a:off x="5656102" y="-6990"/>
            <a:ext cx="23970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iginal band</a:t>
            </a:r>
            <a:endParaRPr lang="ko-KR" altLang="en-US" sz="2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042FF9A1-2FC2-44EE-89F4-066E989C45B1}"/>
              </a:ext>
            </a:extLst>
          </p:cNvPr>
          <p:cNvSpPr/>
          <p:nvPr/>
        </p:nvSpPr>
        <p:spPr>
          <a:xfrm>
            <a:off x="220504" y="411132"/>
            <a:ext cx="524785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9" name="직선 화살표 연결선 18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9322107" y="1163707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79E21066-1E9C-4121-9363-FC69991B450F}"/>
              </a:ext>
            </a:extLst>
          </p:cNvPr>
          <p:cNvSpPr txBox="1"/>
          <p:nvPr/>
        </p:nvSpPr>
        <p:spPr>
          <a:xfrm>
            <a:off x="9928884" y="1980055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l-GR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-actin 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직선 화살표 연결선 20">
            <a:extLst>
              <a:ext uri="{FF2B5EF4-FFF2-40B4-BE49-F238E27FC236}">
                <a16:creationId xmlns:a16="http://schemas.microsoft.com/office/drawing/2014/main" id="{D00E6F62-C6AF-494D-8CAA-33ADE9B3DA41}"/>
              </a:ext>
            </a:extLst>
          </p:cNvPr>
          <p:cNvCxnSpPr>
            <a:cxnSpLocks/>
          </p:cNvCxnSpPr>
          <p:nvPr/>
        </p:nvCxnSpPr>
        <p:spPr>
          <a:xfrm flipH="1">
            <a:off x="9322107" y="2142919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그림 1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6483" y="869862"/>
            <a:ext cx="2948239" cy="691669"/>
          </a:xfrm>
          <a:prstGeom prst="rect">
            <a:avLst/>
          </a:prstGeom>
        </p:spPr>
      </p:pic>
      <p:pic>
        <p:nvPicPr>
          <p:cNvPr id="28" name="그림 2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07071" y="1861542"/>
            <a:ext cx="2647651" cy="736975"/>
          </a:xfrm>
          <a:prstGeom prst="rect">
            <a:avLst/>
          </a:prstGeom>
        </p:spPr>
      </p:pic>
      <p:pic>
        <p:nvPicPr>
          <p:cNvPr id="29" name="그림 28"/>
          <p:cNvPicPr>
            <a:picLocks noChangeAspect="1"/>
          </p:cNvPicPr>
          <p:nvPr/>
        </p:nvPicPr>
        <p:blipFill rotWithShape="1">
          <a:blip r:embed="rId4"/>
          <a:srcRect b="29531"/>
          <a:stretch/>
        </p:blipFill>
        <p:spPr>
          <a:xfrm>
            <a:off x="549090" y="1637155"/>
            <a:ext cx="4590686" cy="3222119"/>
          </a:xfrm>
          <a:prstGeom prst="rect">
            <a:avLst/>
          </a:prstGeom>
        </p:spPr>
      </p:pic>
      <p:pic>
        <p:nvPicPr>
          <p:cNvPr id="32" name="그림 3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46251" y="2806188"/>
            <a:ext cx="2450458" cy="767451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79E21066-1E9C-4121-9363-FC69991B450F}"/>
              </a:ext>
            </a:extLst>
          </p:cNvPr>
          <p:cNvSpPr txBox="1"/>
          <p:nvPr/>
        </p:nvSpPr>
        <p:spPr>
          <a:xfrm>
            <a:off x="9928884" y="3020637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NF-</a:t>
            </a:r>
            <a:r>
              <a:rPr lang="el-GR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직선 화살표 연결선 33">
            <a:extLst>
              <a:ext uri="{FF2B5EF4-FFF2-40B4-BE49-F238E27FC236}">
                <a16:creationId xmlns:a16="http://schemas.microsoft.com/office/drawing/2014/main" id="{D00E6F62-C6AF-494D-8CAA-33ADE9B3DA41}"/>
              </a:ext>
            </a:extLst>
          </p:cNvPr>
          <p:cNvCxnSpPr>
            <a:cxnSpLocks/>
          </p:cNvCxnSpPr>
          <p:nvPr/>
        </p:nvCxnSpPr>
        <p:spPr>
          <a:xfrm flipH="1">
            <a:off x="9322107" y="3183501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7" name="그림 36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462512" y="3886812"/>
            <a:ext cx="2752965" cy="593181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79E21066-1E9C-4121-9363-FC69991B450F}"/>
              </a:ext>
            </a:extLst>
          </p:cNvPr>
          <p:cNvSpPr txBox="1"/>
          <p:nvPr/>
        </p:nvSpPr>
        <p:spPr>
          <a:xfrm>
            <a:off x="9928884" y="4061219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F-</a:t>
            </a:r>
            <a:r>
              <a:rPr lang="el-GR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직선 화살표 연결선 38">
            <a:extLst>
              <a:ext uri="{FF2B5EF4-FFF2-40B4-BE49-F238E27FC236}">
                <a16:creationId xmlns:a16="http://schemas.microsoft.com/office/drawing/2014/main" id="{D00E6F62-C6AF-494D-8CAA-33ADE9B3DA41}"/>
              </a:ext>
            </a:extLst>
          </p:cNvPr>
          <p:cNvCxnSpPr>
            <a:cxnSpLocks/>
          </p:cNvCxnSpPr>
          <p:nvPr/>
        </p:nvCxnSpPr>
        <p:spPr>
          <a:xfrm flipH="1">
            <a:off x="9322107" y="4224083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1" name="그림 40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4764" y="4923798"/>
            <a:ext cx="2964676" cy="807499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79E21066-1E9C-4121-9363-FC69991B450F}"/>
              </a:ext>
            </a:extLst>
          </p:cNvPr>
          <p:cNvSpPr txBox="1"/>
          <p:nvPr/>
        </p:nvSpPr>
        <p:spPr>
          <a:xfrm>
            <a:off x="9928884" y="5101801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min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B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직선 화살표 연결선 42">
            <a:extLst>
              <a:ext uri="{FF2B5EF4-FFF2-40B4-BE49-F238E27FC236}">
                <a16:creationId xmlns:a16="http://schemas.microsoft.com/office/drawing/2014/main" id="{D00E6F62-C6AF-494D-8CAA-33ADE9B3DA41}"/>
              </a:ext>
            </a:extLst>
          </p:cNvPr>
          <p:cNvCxnSpPr>
            <a:cxnSpLocks/>
          </p:cNvCxnSpPr>
          <p:nvPr/>
        </p:nvCxnSpPr>
        <p:spPr>
          <a:xfrm flipH="1">
            <a:off x="9322107" y="5264665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6614437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5166413-B860-4290-92FE-284B309C3354}"/>
              </a:ext>
            </a:extLst>
          </p:cNvPr>
          <p:cNvSpPr txBox="1"/>
          <p:nvPr/>
        </p:nvSpPr>
        <p:spPr>
          <a:xfrm>
            <a:off x="220504" y="-125292"/>
            <a:ext cx="1799278" cy="57996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lnSpc>
                <a:spcPct val="150000"/>
              </a:lnSpc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3 (A) 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189388" y="1869296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I</a:t>
            </a:r>
            <a:r>
              <a:rPr lang="el-GR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4361BA54-F14F-42CC-A066-913816B5BB70}"/>
              </a:ext>
            </a:extLst>
          </p:cNvPr>
          <p:cNvSpPr/>
          <p:nvPr/>
        </p:nvSpPr>
        <p:spPr>
          <a:xfrm>
            <a:off x="5656102" y="411132"/>
            <a:ext cx="630729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2EE29B5-E471-4B21-9AF7-BEC6DE6F607B}"/>
              </a:ext>
            </a:extLst>
          </p:cNvPr>
          <p:cNvSpPr txBox="1"/>
          <p:nvPr/>
        </p:nvSpPr>
        <p:spPr>
          <a:xfrm>
            <a:off x="5656102" y="-6990"/>
            <a:ext cx="23970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iginal band</a:t>
            </a:r>
            <a:endParaRPr lang="ko-KR" altLang="en-US" sz="2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042FF9A1-2FC2-44EE-89F4-066E989C45B1}"/>
              </a:ext>
            </a:extLst>
          </p:cNvPr>
          <p:cNvSpPr/>
          <p:nvPr/>
        </p:nvSpPr>
        <p:spPr>
          <a:xfrm>
            <a:off x="220504" y="411132"/>
            <a:ext cx="524785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9" name="직선 화살표 연결선 18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9641655" y="2053962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화살표 연결선 20">
            <a:extLst>
              <a:ext uri="{FF2B5EF4-FFF2-40B4-BE49-F238E27FC236}">
                <a16:creationId xmlns:a16="http://schemas.microsoft.com/office/drawing/2014/main" id="{D00E6F62-C6AF-494D-8CAA-33ADE9B3DA41}"/>
              </a:ext>
            </a:extLst>
          </p:cNvPr>
          <p:cNvCxnSpPr>
            <a:cxnSpLocks/>
          </p:cNvCxnSpPr>
          <p:nvPr/>
        </p:nvCxnSpPr>
        <p:spPr>
          <a:xfrm flipH="1">
            <a:off x="9641655" y="2938607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BE820524-D89D-47D7-AF52-41EBB8E16DD3}"/>
              </a:ext>
            </a:extLst>
          </p:cNvPr>
          <p:cNvSpPr txBox="1"/>
          <p:nvPr/>
        </p:nvSpPr>
        <p:spPr>
          <a:xfrm>
            <a:off x="10189388" y="3688538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l-GR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-actin 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" name="직선 화살표 연결선 22">
            <a:extLst>
              <a:ext uri="{FF2B5EF4-FFF2-40B4-BE49-F238E27FC236}">
                <a16:creationId xmlns:a16="http://schemas.microsoft.com/office/drawing/2014/main" id="{73693236-22CA-45B6-AAE3-AC8EFD7BFD88}"/>
              </a:ext>
            </a:extLst>
          </p:cNvPr>
          <p:cNvCxnSpPr>
            <a:cxnSpLocks/>
          </p:cNvCxnSpPr>
          <p:nvPr/>
        </p:nvCxnSpPr>
        <p:spPr>
          <a:xfrm flipH="1">
            <a:off x="9641655" y="3833102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그림 12"/>
          <p:cNvPicPr>
            <a:picLocks noChangeAspect="1"/>
          </p:cNvPicPr>
          <p:nvPr/>
        </p:nvPicPr>
        <p:blipFill rotWithShape="1">
          <a:blip r:embed="rId2"/>
          <a:srcRect t="69951"/>
          <a:stretch/>
        </p:blipFill>
        <p:spPr>
          <a:xfrm>
            <a:off x="470723" y="2479030"/>
            <a:ext cx="4590686" cy="1373975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88735" y="1754996"/>
            <a:ext cx="3128804" cy="581562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189388" y="2769330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l-GR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404" t="63444" r="53830" b="33707"/>
          <a:stretch/>
        </p:blipFill>
        <p:spPr>
          <a:xfrm rot="10800000">
            <a:off x="6663353" y="3526006"/>
            <a:ext cx="2901069" cy="622301"/>
          </a:xfrm>
          <a:prstGeom prst="rect">
            <a:avLst/>
          </a:prstGeom>
        </p:spPr>
      </p:pic>
      <p:pic>
        <p:nvPicPr>
          <p:cNvPr id="7" name="그림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0339" y="2666406"/>
            <a:ext cx="2693576" cy="6863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014191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5166413-B860-4290-92FE-284B309C3354}"/>
              </a:ext>
            </a:extLst>
          </p:cNvPr>
          <p:cNvSpPr txBox="1"/>
          <p:nvPr/>
        </p:nvSpPr>
        <p:spPr>
          <a:xfrm>
            <a:off x="220504" y="-125292"/>
            <a:ext cx="179927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lnSpc>
                <a:spcPct val="150000"/>
              </a:lnSpc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3 </a:t>
            </a:r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 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032064" y="991173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ERK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4361BA54-F14F-42CC-A066-913816B5BB70}"/>
              </a:ext>
            </a:extLst>
          </p:cNvPr>
          <p:cNvSpPr/>
          <p:nvPr/>
        </p:nvSpPr>
        <p:spPr>
          <a:xfrm>
            <a:off x="5656102" y="411132"/>
            <a:ext cx="630729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2EE29B5-E471-4B21-9AF7-BEC6DE6F607B}"/>
              </a:ext>
            </a:extLst>
          </p:cNvPr>
          <p:cNvSpPr txBox="1"/>
          <p:nvPr/>
        </p:nvSpPr>
        <p:spPr>
          <a:xfrm>
            <a:off x="5656102" y="-6990"/>
            <a:ext cx="23970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iginal band</a:t>
            </a:r>
            <a:endParaRPr lang="ko-KR" altLang="en-US" sz="2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042FF9A1-2FC2-44EE-89F4-066E989C45B1}"/>
              </a:ext>
            </a:extLst>
          </p:cNvPr>
          <p:cNvSpPr/>
          <p:nvPr/>
        </p:nvSpPr>
        <p:spPr>
          <a:xfrm>
            <a:off x="220504" y="411132"/>
            <a:ext cx="524785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9" name="직선 화살표 연결선 18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9402180" y="1196438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3" name="그림 1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0969" y="1381104"/>
            <a:ext cx="4328535" cy="3633531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64593" y="872797"/>
            <a:ext cx="2901258" cy="586536"/>
          </a:xfrm>
          <a:prstGeom prst="rect">
            <a:avLst/>
          </a:prstGeom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57114" y="1749790"/>
            <a:ext cx="2689500" cy="596052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032064" y="1873869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RK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직선 화살표 연결선 26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9402180" y="2079134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그림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84656" y="2636300"/>
            <a:ext cx="2737012" cy="478214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032064" y="2660049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JNK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직선 화살표 연결선 28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9402180" y="2865314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" name="그림 6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765241" y="3478621"/>
            <a:ext cx="2468143" cy="691080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032064" y="3584152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NK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1" name="직선 화살표 연결선 30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9402180" y="3750780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그림 1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416639" y="4413020"/>
            <a:ext cx="2970450" cy="615637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029916" y="4509279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ko-KR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4" name="직선 화살표 연결선 33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9400032" y="4675907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그림 13"/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61754" y="5299529"/>
            <a:ext cx="3138278" cy="546821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029916" y="5307332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38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직선 화살표 연결선 35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9400032" y="5473960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3820327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5166413-B860-4290-92FE-284B309C3354}"/>
              </a:ext>
            </a:extLst>
          </p:cNvPr>
          <p:cNvSpPr txBox="1"/>
          <p:nvPr/>
        </p:nvSpPr>
        <p:spPr>
          <a:xfrm>
            <a:off x="220504" y="-125292"/>
            <a:ext cx="22403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lnSpc>
                <a:spcPct val="150000"/>
              </a:lnSpc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 </a:t>
            </a:r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E) 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4361BA54-F14F-42CC-A066-913816B5BB70}"/>
              </a:ext>
            </a:extLst>
          </p:cNvPr>
          <p:cNvSpPr/>
          <p:nvPr/>
        </p:nvSpPr>
        <p:spPr>
          <a:xfrm>
            <a:off x="5656102" y="411132"/>
            <a:ext cx="630729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2EE29B5-E471-4B21-9AF7-BEC6DE6F607B}"/>
              </a:ext>
            </a:extLst>
          </p:cNvPr>
          <p:cNvSpPr txBox="1"/>
          <p:nvPr/>
        </p:nvSpPr>
        <p:spPr>
          <a:xfrm>
            <a:off x="5656102" y="-6990"/>
            <a:ext cx="23970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iginal band</a:t>
            </a:r>
            <a:endParaRPr lang="ko-KR" altLang="en-US" sz="2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042FF9A1-2FC2-44EE-89F4-066E989C45B1}"/>
              </a:ext>
            </a:extLst>
          </p:cNvPr>
          <p:cNvSpPr/>
          <p:nvPr/>
        </p:nvSpPr>
        <p:spPr>
          <a:xfrm>
            <a:off x="220504" y="411132"/>
            <a:ext cx="524785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9" name="그림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17936" y="2693323"/>
            <a:ext cx="2243522" cy="566977"/>
          </a:xfrm>
          <a:prstGeom prst="rect">
            <a:avLst/>
          </a:prstGeom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17936" y="1891159"/>
            <a:ext cx="2267909" cy="585267"/>
          </a:xfrm>
          <a:prstGeom prst="rect">
            <a:avLst/>
          </a:prstGeom>
        </p:spPr>
      </p:pic>
      <p:pic>
        <p:nvPicPr>
          <p:cNvPr id="15" name="그림 14"/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749" t="35459" r="17091" b="61397"/>
          <a:stretch/>
        </p:blipFill>
        <p:spPr>
          <a:xfrm rot="10800000">
            <a:off x="6761836" y="3477197"/>
            <a:ext cx="2155721" cy="527537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9525981" y="2838951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altLang="ko-KR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os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직선 화살표 연결선 38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8978248" y="3023617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직선 화살표 연결선 39">
            <a:extLst>
              <a:ext uri="{FF2B5EF4-FFF2-40B4-BE49-F238E27FC236}">
                <a16:creationId xmlns:a16="http://schemas.microsoft.com/office/drawing/2014/main" id="{D00E6F62-C6AF-494D-8CAA-33ADE9B3DA41}"/>
              </a:ext>
            </a:extLst>
          </p:cNvPr>
          <p:cNvCxnSpPr>
            <a:cxnSpLocks/>
          </p:cNvCxnSpPr>
          <p:nvPr/>
        </p:nvCxnSpPr>
        <p:spPr>
          <a:xfrm flipH="1">
            <a:off x="8978248" y="2317329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BE820524-D89D-47D7-AF52-41EBB8E16DD3}"/>
              </a:ext>
            </a:extLst>
          </p:cNvPr>
          <p:cNvSpPr txBox="1"/>
          <p:nvPr/>
        </p:nvSpPr>
        <p:spPr>
          <a:xfrm>
            <a:off x="9525981" y="3526084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l-GR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-actin 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2" name="직선 화살표 연결선 41">
            <a:extLst>
              <a:ext uri="{FF2B5EF4-FFF2-40B4-BE49-F238E27FC236}">
                <a16:creationId xmlns:a16="http://schemas.microsoft.com/office/drawing/2014/main" id="{73693236-22CA-45B6-AAE3-AC8EFD7BFD88}"/>
              </a:ext>
            </a:extLst>
          </p:cNvPr>
          <p:cNvCxnSpPr>
            <a:cxnSpLocks/>
          </p:cNvCxnSpPr>
          <p:nvPr/>
        </p:nvCxnSpPr>
        <p:spPr>
          <a:xfrm flipH="1">
            <a:off x="8978248" y="3670648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9525981" y="2148052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FATc</a:t>
            </a:r>
            <a:r>
              <a:rPr lang="en-US" altLang="ko-KR" sz="1600" b="1" dirty="0" err="1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그림 1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1896" y="1571453"/>
            <a:ext cx="4743164" cy="29043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807515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5166413-B860-4290-92FE-284B309C3354}"/>
              </a:ext>
            </a:extLst>
          </p:cNvPr>
          <p:cNvSpPr txBox="1"/>
          <p:nvPr/>
        </p:nvSpPr>
        <p:spPr>
          <a:xfrm>
            <a:off x="220504" y="-125292"/>
            <a:ext cx="22403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lnSpc>
                <a:spcPct val="150000"/>
              </a:lnSpc>
            </a:pPr>
            <a:r>
              <a:rPr lang="en-US" altLang="ko-KR" sz="2400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ko-K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2 (H) 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직사각형 15">
            <a:extLst>
              <a:ext uri="{FF2B5EF4-FFF2-40B4-BE49-F238E27FC236}">
                <a16:creationId xmlns:a16="http://schemas.microsoft.com/office/drawing/2014/main" id="{4361BA54-F14F-42CC-A066-913816B5BB70}"/>
              </a:ext>
            </a:extLst>
          </p:cNvPr>
          <p:cNvSpPr/>
          <p:nvPr/>
        </p:nvSpPr>
        <p:spPr>
          <a:xfrm>
            <a:off x="5656102" y="411132"/>
            <a:ext cx="630729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2EE29B5-E471-4B21-9AF7-BEC6DE6F607B}"/>
              </a:ext>
            </a:extLst>
          </p:cNvPr>
          <p:cNvSpPr txBox="1"/>
          <p:nvPr/>
        </p:nvSpPr>
        <p:spPr>
          <a:xfrm>
            <a:off x="5656102" y="-6990"/>
            <a:ext cx="239703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24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riginal band</a:t>
            </a:r>
            <a:endParaRPr lang="ko-KR" altLang="en-US" sz="2400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직사각형 17">
            <a:extLst>
              <a:ext uri="{FF2B5EF4-FFF2-40B4-BE49-F238E27FC236}">
                <a16:creationId xmlns:a16="http://schemas.microsoft.com/office/drawing/2014/main" id="{042FF9A1-2FC2-44EE-89F4-066E989C45B1}"/>
              </a:ext>
            </a:extLst>
          </p:cNvPr>
          <p:cNvSpPr/>
          <p:nvPr/>
        </p:nvSpPr>
        <p:spPr>
          <a:xfrm>
            <a:off x="220504" y="411132"/>
            <a:ext cx="5247858" cy="620061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2" name="그림 11"/>
          <p:cNvPicPr>
            <a:picLocks noChangeAspect="1"/>
          </p:cNvPicPr>
          <p:nvPr/>
        </p:nvPicPr>
        <p:blipFill rotWithShape="1">
          <a:blip r:embed="rId2"/>
          <a:srcRect t="13735"/>
          <a:stretch/>
        </p:blipFill>
        <p:spPr>
          <a:xfrm>
            <a:off x="6669155" y="5483225"/>
            <a:ext cx="2731245" cy="541689"/>
          </a:xfrm>
          <a:prstGeom prst="rect">
            <a:avLst/>
          </a:prstGeom>
        </p:spPr>
      </p:pic>
      <p:pic>
        <p:nvPicPr>
          <p:cNvPr id="13" name="그림 12"/>
          <p:cNvPicPr>
            <a:picLocks noChangeAspect="1"/>
          </p:cNvPicPr>
          <p:nvPr/>
        </p:nvPicPr>
        <p:blipFill rotWithShape="1">
          <a:blip r:embed="rId3"/>
          <a:srcRect t="19821" b="15369"/>
          <a:stretch/>
        </p:blipFill>
        <p:spPr>
          <a:xfrm>
            <a:off x="6467840" y="4492864"/>
            <a:ext cx="2932560" cy="651210"/>
          </a:xfrm>
          <a:prstGeom prst="rect">
            <a:avLst/>
          </a:prstGeom>
        </p:spPr>
      </p:pic>
      <p:pic>
        <p:nvPicPr>
          <p:cNvPr id="14" name="그림 13"/>
          <p:cNvPicPr>
            <a:picLocks noChangeAspect="1"/>
          </p:cNvPicPr>
          <p:nvPr/>
        </p:nvPicPr>
        <p:blipFill rotWithShape="1">
          <a:blip r:embed="rId4"/>
          <a:srcRect t="23223" b="24101"/>
          <a:stretch/>
        </p:blipFill>
        <p:spPr>
          <a:xfrm>
            <a:off x="6439339" y="3516682"/>
            <a:ext cx="2961061" cy="751196"/>
          </a:xfrm>
          <a:prstGeom prst="rect">
            <a:avLst/>
          </a:prstGeom>
        </p:spPr>
      </p:pic>
      <p:pic>
        <p:nvPicPr>
          <p:cNvPr id="4" name="그림 3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2755" y="1975258"/>
            <a:ext cx="2987893" cy="539829"/>
          </a:xfrm>
          <a:prstGeom prst="rect">
            <a:avLst/>
          </a:prstGeom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2755" y="1125841"/>
            <a:ext cx="2953053" cy="604673"/>
          </a:xfrm>
          <a:prstGeom prst="rect">
            <a:avLst/>
          </a:prstGeom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393147" y="2790079"/>
            <a:ext cx="2918525" cy="491767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021280" y="2010276"/>
            <a:ext cx="14722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-SAMD 1/5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7" name="직선 화살표 연결선 26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9473548" y="2194942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화살표 연결선 27">
            <a:extLst>
              <a:ext uri="{FF2B5EF4-FFF2-40B4-BE49-F238E27FC236}">
                <a16:creationId xmlns:a16="http://schemas.microsoft.com/office/drawing/2014/main" id="{D00E6F62-C6AF-494D-8CAA-33ADE9B3DA41}"/>
              </a:ext>
            </a:extLst>
          </p:cNvPr>
          <p:cNvCxnSpPr>
            <a:cxnSpLocks/>
          </p:cNvCxnSpPr>
          <p:nvPr/>
        </p:nvCxnSpPr>
        <p:spPr>
          <a:xfrm flipH="1">
            <a:off x="9473548" y="1488654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BE820524-D89D-47D7-AF52-41EBB8E16DD3}"/>
              </a:ext>
            </a:extLst>
          </p:cNvPr>
          <p:cNvSpPr txBox="1"/>
          <p:nvPr/>
        </p:nvSpPr>
        <p:spPr>
          <a:xfrm>
            <a:off x="10021280" y="2876586"/>
            <a:ext cx="147221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SAMD </a:t>
            </a:r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/5/9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직선 화살표 연결선 29">
            <a:extLst>
              <a:ext uri="{FF2B5EF4-FFF2-40B4-BE49-F238E27FC236}">
                <a16:creationId xmlns:a16="http://schemas.microsoft.com/office/drawing/2014/main" id="{73693236-22CA-45B6-AAE3-AC8EFD7BFD88}"/>
              </a:ext>
            </a:extLst>
          </p:cNvPr>
          <p:cNvCxnSpPr>
            <a:cxnSpLocks/>
          </p:cNvCxnSpPr>
          <p:nvPr/>
        </p:nvCxnSpPr>
        <p:spPr>
          <a:xfrm flipH="1">
            <a:off x="9473548" y="3021150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021280" y="1319377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MP-2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021280" y="4433796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sterix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직선 화살표 연결선 32">
            <a:extLst>
              <a:ext uri="{FF2B5EF4-FFF2-40B4-BE49-F238E27FC236}">
                <a16:creationId xmlns:a16="http://schemas.microsoft.com/office/drawing/2014/main" id="{22520A05-4442-4260-A520-F5DC7627A762}"/>
              </a:ext>
            </a:extLst>
          </p:cNvPr>
          <p:cNvCxnSpPr>
            <a:cxnSpLocks/>
          </p:cNvCxnSpPr>
          <p:nvPr/>
        </p:nvCxnSpPr>
        <p:spPr>
          <a:xfrm flipH="1">
            <a:off x="9473548" y="4618462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직선 화살표 연결선 33">
            <a:extLst>
              <a:ext uri="{FF2B5EF4-FFF2-40B4-BE49-F238E27FC236}">
                <a16:creationId xmlns:a16="http://schemas.microsoft.com/office/drawing/2014/main" id="{D00E6F62-C6AF-494D-8CAA-33ADE9B3DA41}"/>
              </a:ext>
            </a:extLst>
          </p:cNvPr>
          <p:cNvCxnSpPr>
            <a:cxnSpLocks/>
          </p:cNvCxnSpPr>
          <p:nvPr/>
        </p:nvCxnSpPr>
        <p:spPr>
          <a:xfrm flipH="1">
            <a:off x="9473548" y="3912174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BE820524-D89D-47D7-AF52-41EBB8E16DD3}"/>
              </a:ext>
            </a:extLst>
          </p:cNvPr>
          <p:cNvSpPr txBox="1"/>
          <p:nvPr/>
        </p:nvSpPr>
        <p:spPr>
          <a:xfrm>
            <a:off x="10021280" y="5445830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l-GR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altLang="ko-KR" sz="1600" b="1" dirty="0">
                <a:latin typeface="Arial" panose="020B0604020202020204" pitchFamily="34" charset="0"/>
                <a:cs typeface="Arial" panose="020B0604020202020204" pitchFamily="34" charset="0"/>
              </a:rPr>
              <a:t>-actin 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6" name="직선 화살표 연결선 35">
            <a:extLst>
              <a:ext uri="{FF2B5EF4-FFF2-40B4-BE49-F238E27FC236}">
                <a16:creationId xmlns:a16="http://schemas.microsoft.com/office/drawing/2014/main" id="{73693236-22CA-45B6-AAE3-AC8EFD7BFD88}"/>
              </a:ext>
            </a:extLst>
          </p:cNvPr>
          <p:cNvCxnSpPr>
            <a:cxnSpLocks/>
          </p:cNvCxnSpPr>
          <p:nvPr/>
        </p:nvCxnSpPr>
        <p:spPr>
          <a:xfrm flipH="1">
            <a:off x="9473548" y="5590394"/>
            <a:ext cx="549372" cy="0"/>
          </a:xfrm>
          <a:prstGeom prst="straightConnector1">
            <a:avLst/>
          </a:prstGeom>
          <a:ln w="571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B3F2185C-546C-457C-8E0B-EE937357C176}"/>
              </a:ext>
            </a:extLst>
          </p:cNvPr>
          <p:cNvSpPr txBox="1"/>
          <p:nvPr/>
        </p:nvSpPr>
        <p:spPr>
          <a:xfrm>
            <a:off x="10021280" y="3742897"/>
            <a:ext cx="11208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UNX2</a:t>
            </a:r>
            <a:endParaRPr lang="ko-KR" alt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그림 3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78895" y="1180502"/>
            <a:ext cx="3731075" cy="40359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157943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00</TotalTime>
  <Words>73</Words>
  <Application>Microsoft Office PowerPoint</Application>
  <PresentationFormat>와이드스크린</PresentationFormat>
  <Paragraphs>33</Paragraphs>
  <Slides>5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5</vt:i4>
      </vt:variant>
    </vt:vector>
  </HeadingPairs>
  <TitlesOfParts>
    <vt:vector size="8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민선</dc:creator>
  <cp:lastModifiedBy>김민선</cp:lastModifiedBy>
  <cp:revision>39</cp:revision>
  <dcterms:created xsi:type="dcterms:W3CDTF">2021-10-18T01:54:40Z</dcterms:created>
  <dcterms:modified xsi:type="dcterms:W3CDTF">2021-11-19T11:48:33Z</dcterms:modified>
</cp:coreProperties>
</file>